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6" d="100"/>
          <a:sy n="106" d="100"/>
        </p:scale>
        <p:origin x="75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425C77-13F8-DFF7-EF53-2A645C2B925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6AAE7F9-A7F2-2157-5A5D-6395AAFB1DA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55C604-AE30-DBF3-C49F-5E1E56EB03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60450-68B6-4638-A625-4EF345B82A23}" type="datetimeFigureOut">
              <a:rPr lang="en-US" smtClean="0"/>
              <a:t>3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01F657-D09D-9E1F-CF8D-54EB032034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57F469-83E6-1626-E15E-F954F61FFB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1F185-D4BE-4146-AF7E-FBD208C0E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58295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DFBDB7-0D39-421B-D495-27562E5AB2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C74978B-1BF3-617F-B1D7-F9BB1F58A78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009D10-4A69-6E99-BCC4-5A88426530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60450-68B6-4638-A625-4EF345B82A23}" type="datetimeFigureOut">
              <a:rPr lang="en-US" smtClean="0"/>
              <a:t>3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2F530C-C392-5F97-A8D9-A8E909E787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32B9BB-BA27-F201-B7A3-A594A9D226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1F185-D4BE-4146-AF7E-FBD208C0E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59713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A0E348B-FE90-74EC-0569-A0293CF7FA9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B5F0448-E601-8AAD-5083-FFB48077A3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DEF95C-CEA1-8822-2CAF-99D9EAF293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60450-68B6-4638-A625-4EF345B82A23}" type="datetimeFigureOut">
              <a:rPr lang="en-US" smtClean="0"/>
              <a:t>3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82CBC5-22A1-360F-1751-5D3E8A6CE5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FCD308-BB2D-1FC1-CC8B-883DA7739F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1F185-D4BE-4146-AF7E-FBD208C0E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47332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934F9F-4238-6AB7-9370-E8F9433D26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252854-C9DB-6114-1383-ABD09696677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B48F16-7660-F027-2CE5-AF70D503B5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60450-68B6-4638-A625-4EF345B82A23}" type="datetimeFigureOut">
              <a:rPr lang="en-US" smtClean="0"/>
              <a:t>3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63D5DB-0EEA-DF66-D24D-2F9CE23EC3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3649F0-6B74-393B-C87F-D794B071C3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1F185-D4BE-4146-AF7E-FBD208C0E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30118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DD2634-1350-3BB8-E08E-2526758AF7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3691CB2-8E43-ACAD-2DE8-54E66C8BB7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3B89D1-A76A-256E-CDF7-1DF8ADF6CA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60450-68B6-4638-A625-4EF345B82A23}" type="datetimeFigureOut">
              <a:rPr lang="en-US" smtClean="0"/>
              <a:t>3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B24BC5-D6A7-8D6B-A85A-20CE41128E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9C9E1C-5087-933B-7945-51A4FC74CB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1F185-D4BE-4146-AF7E-FBD208C0E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29851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4EF8BD-8A78-E5A5-D633-C2005CDDD4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19E638-A004-CEBB-3CAF-0514F77D82B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74DA45-5BFA-C24E-DD24-B5888AEA9A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614BF3-7232-1EA1-9487-0F16665BED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60450-68B6-4638-A625-4EF345B82A23}" type="datetimeFigureOut">
              <a:rPr lang="en-US" smtClean="0"/>
              <a:t>3/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3CBA90-3953-EF97-87CC-95213AD236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C9E6AE1-069C-9592-C49D-90759E2945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1F185-D4BE-4146-AF7E-FBD208C0E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78783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2E14EE-C4B3-FEE0-A07D-35DDF1B080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A19DBD9-36A2-FF3D-CB11-1D87029851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A0FE364-9182-D538-78D9-888A44F64B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AC701DA-EF46-668C-57B7-36730D19E7B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518BCBC-6383-EF37-19D2-55560AB78E7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4E757C5-5A0F-6788-7981-3F507A5D53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60450-68B6-4638-A625-4EF345B82A23}" type="datetimeFigureOut">
              <a:rPr lang="en-US" smtClean="0"/>
              <a:t>3/4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D2ADD6D-C215-1B4C-855E-95496FD5F0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5554600-C9A4-EFFB-2505-283D2FD2C9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1F185-D4BE-4146-AF7E-FBD208C0E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7665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874B4E-955C-7074-A202-5C34D7AB06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2B0138E-B2C2-9BC2-EC90-3FBD8ACA0E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60450-68B6-4638-A625-4EF345B82A23}" type="datetimeFigureOut">
              <a:rPr lang="en-US" smtClean="0"/>
              <a:t>3/4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2D75CD7-9DBC-F921-9566-9FD6739A7C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3DE348F-1802-E849-370D-FFB67825BA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1F185-D4BE-4146-AF7E-FBD208C0E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30041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BF0A2D6-0BCB-515D-AE6E-F42793D8D9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60450-68B6-4638-A625-4EF345B82A23}" type="datetimeFigureOut">
              <a:rPr lang="en-US" smtClean="0"/>
              <a:t>3/4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C9AB6BB-A634-48CD-9149-11935CF84A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E84C8C9-2929-AB48-7210-B687914FF3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1F185-D4BE-4146-AF7E-FBD208C0E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26425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904156-C1ED-CDED-E44B-41FDBD0807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EF32697-4B69-F5F5-2B99-8A17B1C9610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E61EBE7-837A-A758-253E-E632DF3CAB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022431-CE95-323F-5057-AC743029D9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60450-68B6-4638-A625-4EF345B82A23}" type="datetimeFigureOut">
              <a:rPr lang="en-US" smtClean="0"/>
              <a:t>3/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FD39631-EF14-67AC-DECB-3B5F5031AE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FF32C7F-C82F-1CE3-5760-21304448AE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1F185-D4BE-4146-AF7E-FBD208C0E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2240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F9EFC6-724F-36A0-B5CA-88042DCBB7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1F31B3C-CA30-08FA-3368-CACFE6097C4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27DE9D-AB8F-0AB2-DC7A-B13BF70BA2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9FC954D-A20E-244B-6BF5-AF664B3349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60450-68B6-4638-A625-4EF345B82A23}" type="datetimeFigureOut">
              <a:rPr lang="en-US" smtClean="0"/>
              <a:t>3/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8BD7405-785A-04ED-E703-EFF0938C8D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6D7CC3-81B7-8B6F-28BC-B674FFB9C9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1F185-D4BE-4146-AF7E-FBD208C0E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04501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AE868A8-21B4-CE39-AE31-AE51C7031D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E8CFE4F-2F8F-802C-BACB-CD4D492B7E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2819B4-940B-32FD-E6FF-92978311068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9C60450-68B6-4638-A625-4EF345B82A23}" type="datetimeFigureOut">
              <a:rPr lang="en-US" smtClean="0"/>
              <a:t>3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887B00-6A86-82A8-3F82-5F3FAB8ABA2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8E5F60-501B-6E39-98B9-7AC6D022545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6D1F185-D4BE-4146-AF7E-FBD208C0E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84821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F67092B3-F25B-E9C1-A783-5C078906CA8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08351234"/>
              </p:ext>
            </p:extLst>
          </p:nvPr>
        </p:nvGraphicFramePr>
        <p:xfrm>
          <a:off x="3602038" y="1062038"/>
          <a:ext cx="4986337" cy="4730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4986799" imgH="4730983" progId="Prism10.Document">
                  <p:embed/>
                </p:oleObj>
              </mc:Choice>
              <mc:Fallback>
                <p:oleObj name="Prism 10" r:id="rId2" imgW="4986799" imgH="4730983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602038" y="1062038"/>
                        <a:ext cx="4986337" cy="4730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64514C80-DFB5-9862-76F5-99038FBFFE13}"/>
              </a:ext>
            </a:extLst>
          </p:cNvPr>
          <p:cNvSpPr txBox="1"/>
          <p:nvPr/>
        </p:nvSpPr>
        <p:spPr>
          <a:xfrm>
            <a:off x="1421394" y="823865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4</a:t>
            </a:r>
          </a:p>
        </p:txBody>
      </p:sp>
    </p:spTree>
    <p:extLst>
      <p:ext uri="{BB962C8B-B14F-4D97-AF65-F5344CB8AC3E}">
        <p14:creationId xmlns:p14="http://schemas.microsoft.com/office/powerpoint/2010/main" val="40375157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928520C-83B0-916A-62DA-E6EF08DDCBF1}"/>
              </a:ext>
            </a:extLst>
          </p:cNvPr>
          <p:cNvSpPr txBox="1"/>
          <p:nvPr/>
        </p:nvSpPr>
        <p:spPr>
          <a:xfrm>
            <a:off x="1306717" y="1004935"/>
            <a:ext cx="957856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4. Transgenic expression of human OATP1B1 or OATP1B3 does not recapitulate the Oatp1a/1b deficiency.</a:t>
            </a:r>
            <a:r>
              <a:rPr lang="en-US" sz="1200" dirty="0"/>
              <a:t> Pharmacokinetic profile of letrozole after a single oral dose 10mg/kg in A) wild-type, Oatp1a/1b(-/-), OATP1B1(</a:t>
            </a:r>
            <a:r>
              <a:rPr lang="en-US" sz="1200" dirty="0" err="1"/>
              <a:t>tg</a:t>
            </a:r>
            <a:r>
              <a:rPr lang="en-US" sz="1200" dirty="0"/>
              <a:t>) or OATP1B3(</a:t>
            </a:r>
            <a:r>
              <a:rPr lang="en-US" sz="1200" dirty="0" err="1"/>
              <a:t>tg</a:t>
            </a:r>
            <a:r>
              <a:rPr lang="en-US" sz="1200" dirty="0"/>
              <a:t>) mice (Oatp1a/1b(−/−) mice with transgenic hepatic expression of OATP1B1 or OATP1B3) and B) liver letrozole concentration of represented genotypes. Pharmacokinetic profile of exemestane after a single oral dose 20 mg/kg in C) wild-type and Oatp1a/1b(-/-), and OATP1B3(</a:t>
            </a:r>
            <a:r>
              <a:rPr lang="en-US" sz="1200" dirty="0" err="1"/>
              <a:t>tg</a:t>
            </a:r>
            <a:r>
              <a:rPr lang="en-US" sz="1200" dirty="0"/>
              <a:t>) mice. D) Liver exemestane concentration in the representative genotypes. Plasma concentrations of letrozole and exemestane were analyzed by LC-MS/MS. The maximum plasma concentration </a:t>
            </a:r>
            <a:r>
              <a:rPr lang="en-US" sz="1200" dirty="0" err="1"/>
              <a:t>Cmax</a:t>
            </a:r>
            <a:r>
              <a:rPr lang="en-US" sz="1200" dirty="0"/>
              <a:t>, and Area Under the Curve (AUC0-6h) values are summarized in Table 2. PK parameters (n=8-10 per genotype) were calculated by non-compartmental analysis using Phoenix </a:t>
            </a:r>
            <a:r>
              <a:rPr lang="en-US" sz="1200" dirty="0" err="1"/>
              <a:t>WinNonlin</a:t>
            </a:r>
            <a:r>
              <a:rPr lang="en-US" sz="1200" dirty="0"/>
              <a:t> 8.1 (RRID:SCR_024504). One-way ANOVA with Dunnett’s multiple comparison adjustment was used to analyze the data. NS = non-significant; B) P = 0.513 and D) P = 0.128 for Oatp1a/1b(-/-) compared to wild-type. denotes P&lt; 0.05 versus wild-type group. Data are represented as mean and SD. P&lt;0.05 compared to wild-type group. </a:t>
            </a:r>
          </a:p>
        </p:txBody>
      </p:sp>
    </p:spTree>
    <p:extLst>
      <p:ext uri="{BB962C8B-B14F-4D97-AF65-F5344CB8AC3E}">
        <p14:creationId xmlns:p14="http://schemas.microsoft.com/office/powerpoint/2010/main" val="41839089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1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GraphPad Prism Project</vt:lpstr>
      <vt:lpstr>PowerPoint Presentation</vt:lpstr>
      <vt:lpstr>PowerPoint Presentation</vt:lpstr>
    </vt:vector>
  </TitlesOfParts>
  <Company>The Ohio Stat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u, Shuiying</dc:creator>
  <cp:lastModifiedBy>Hu, Shuiying</cp:lastModifiedBy>
  <cp:revision>1</cp:revision>
  <dcterms:created xsi:type="dcterms:W3CDTF">2025-03-05T03:27:09Z</dcterms:created>
  <dcterms:modified xsi:type="dcterms:W3CDTF">2025-03-05T03:27:48Z</dcterms:modified>
</cp:coreProperties>
</file>